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handoutMasterIdLst>
    <p:handoutMasterId r:id="rId5"/>
  </p:handoutMasterIdLst>
  <p:sldIdLst>
    <p:sldId id="456" r:id="rId2"/>
    <p:sldId id="457" r:id="rId3"/>
  </p:sldIdLst>
  <p:sldSz cx="6858000" cy="9144000" type="letter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0B850B"/>
    <a:srgbClr val="0000FF"/>
    <a:srgbClr val="7FBF7B"/>
    <a:srgbClr val="AF8DC4"/>
    <a:srgbClr val="1A48D4"/>
    <a:srgbClr val="1A49D3"/>
    <a:srgbClr val="5B9BD5"/>
    <a:srgbClr val="593AF6"/>
    <a:srgbClr val="E4181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888" autoAdjust="0"/>
    <p:restoredTop sz="94133" autoAdjust="0"/>
  </p:normalViewPr>
  <p:slideViewPr>
    <p:cSldViewPr snapToGrid="0">
      <p:cViewPr varScale="1">
        <p:scale>
          <a:sx n="51" d="100"/>
          <a:sy n="51" d="100"/>
        </p:scale>
        <p:origin x="2349" y="39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53" d="100"/>
          <a:sy n="53" d="100"/>
        </p:scale>
        <p:origin x="2648" y="6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119" cy="466434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98102" y="0"/>
            <a:ext cx="2982119" cy="466434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r">
              <a:defRPr sz="1200"/>
            </a:lvl1pPr>
          </a:lstStyle>
          <a:p>
            <a:fld id="{100B70CD-68BD-4320-8AC8-AEE39ADB471E}" type="datetimeFigureOut">
              <a:rPr lang="en-US" smtClean="0"/>
              <a:t>10/2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967"/>
            <a:ext cx="2982119" cy="466433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98102" y="8829967"/>
            <a:ext cx="2982119" cy="466433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r">
              <a:defRPr sz="1200"/>
            </a:lvl1pPr>
          </a:lstStyle>
          <a:p>
            <a:fld id="{3CA30B30-85F0-4A81-BE1C-CE97D2FA8E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701694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119" cy="466434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8102" y="0"/>
            <a:ext cx="2982119" cy="466434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r">
              <a:defRPr sz="1200"/>
            </a:lvl1pPr>
          </a:lstStyle>
          <a:p>
            <a:fld id="{C04982FE-ED46-423F-8AFB-B79C0719A48F}" type="datetimeFigureOut">
              <a:rPr lang="en-US" smtClean="0"/>
              <a:t>10/27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65363" y="1162050"/>
            <a:ext cx="2351087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46" tIns="46223" rIns="92446" bIns="4622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182" y="4473892"/>
            <a:ext cx="5505450" cy="3660458"/>
          </a:xfrm>
          <a:prstGeom prst="rect">
            <a:avLst/>
          </a:prstGeom>
        </p:spPr>
        <p:txBody>
          <a:bodyPr vert="horz" lIns="92446" tIns="46223" rIns="92446" bIns="46223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82119" cy="466433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8102" y="8829967"/>
            <a:ext cx="2982119" cy="466433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r">
              <a:defRPr sz="1200"/>
            </a:lvl1pPr>
          </a:lstStyle>
          <a:p>
            <a:fld id="{197AE16C-AF19-4A4D-9046-550099D7C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95339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F7216-0042-4CA8-A7DB-B437E02041C4}" type="datetime1">
              <a:rPr lang="en-US" smtClean="0"/>
              <a:t>10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ACF0C-1E73-4354-B582-C6A4ACB1AA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374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F4059-EE0F-4869-8E5C-CDB18B6F4A69}" type="datetime1">
              <a:rPr lang="en-US" smtClean="0"/>
              <a:t>10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ACF0C-1E73-4354-B582-C6A4ACB1AA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291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0DD98-EC93-4F09-98FF-7337927E97D6}" type="datetime1">
              <a:rPr lang="en-US" smtClean="0"/>
              <a:t>10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ACF0C-1E73-4354-B582-C6A4ACB1AA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600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C49A9-B31D-492E-B938-85EA996AE176}" type="datetime1">
              <a:rPr lang="en-US" smtClean="0"/>
              <a:t>10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ACF0C-1E73-4354-B582-C6A4ACB1AA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21999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1F191-E428-4DFA-93F7-C892A6DE0876}" type="datetime1">
              <a:rPr lang="en-US" smtClean="0"/>
              <a:t>10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ACF0C-1E73-4354-B582-C6A4ACB1AA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35102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334CF-2851-4429-8FC2-75E02E4849F7}" type="datetime1">
              <a:rPr lang="en-US" smtClean="0"/>
              <a:t>10/2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ACF0C-1E73-4354-B582-C6A4ACB1AA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2610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D20E72-D918-4453-AEF8-3D4AC30F54CC}" type="datetime1">
              <a:rPr lang="en-US" smtClean="0"/>
              <a:t>10/2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ACF0C-1E73-4354-B582-C6A4ACB1AA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9829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EEFE0A-FBC9-434F-88F1-4C2EDE46EC41}" type="datetime1">
              <a:rPr lang="en-US" smtClean="0"/>
              <a:t>10/2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ACF0C-1E73-4354-B582-C6A4ACB1AA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22280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B3BB2-1E1D-4E74-B19F-992C5D36D8C8}" type="datetime1">
              <a:rPr lang="en-US" smtClean="0"/>
              <a:t>10/2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ACF0C-1E73-4354-B582-C6A4ACB1AA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2077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FAA8E-9D7C-4DB6-A43A-F9E126DE60C2}" type="datetime1">
              <a:rPr lang="en-US" smtClean="0"/>
              <a:t>10/2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ACF0C-1E73-4354-B582-C6A4ACB1AA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0063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D45BB-0091-41D9-B318-6566B6C64840}" type="datetime1">
              <a:rPr lang="en-US" smtClean="0"/>
              <a:t>10/2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ACF0C-1E73-4354-B582-C6A4ACB1AA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5097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622F46-1A14-413D-A96B-3E2F9B0BEA48}" type="datetime1">
              <a:rPr lang="en-US" smtClean="0"/>
              <a:t>10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FACF0C-1E73-4354-B582-C6A4ACB1AA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3546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FB3BE942-AE05-8040-989E-ACFFE158108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73" t="332" r="18877" b="9136"/>
          <a:stretch/>
        </p:blipFill>
        <p:spPr>
          <a:xfrm>
            <a:off x="71051" y="880579"/>
            <a:ext cx="6499751" cy="6581882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44F0F6C5-37A4-4887-950D-C289693F49AD}"/>
              </a:ext>
            </a:extLst>
          </p:cNvPr>
          <p:cNvSpPr/>
          <p:nvPr/>
        </p:nvSpPr>
        <p:spPr>
          <a:xfrm>
            <a:off x="287198" y="343499"/>
            <a:ext cx="649975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2. Consensus sequences identified for ETS protein by DAPPL using 16-mer DNA library.</a:t>
            </a:r>
          </a:p>
        </p:txBody>
      </p:sp>
    </p:spTree>
    <p:extLst>
      <p:ext uri="{BB962C8B-B14F-4D97-AF65-F5344CB8AC3E}">
        <p14:creationId xmlns:p14="http://schemas.microsoft.com/office/powerpoint/2010/main" val="22807675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BB60290-07DD-794E-92DB-C2A652A11B3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80" t="866" r="17874" b="26135"/>
          <a:stretch/>
        </p:blipFill>
        <p:spPr>
          <a:xfrm>
            <a:off x="261784" y="1335931"/>
            <a:ext cx="6605679" cy="55402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86976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044</TotalTime>
  <Words>17</Words>
  <Application>Microsoft Office PowerPoint</Application>
  <PresentationFormat>Letter Paper (8.5x11 in)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u Lab</dc:creator>
  <cp:lastModifiedBy>Guang Song</cp:lastModifiedBy>
  <cp:revision>836</cp:revision>
  <cp:lastPrinted>2020-06-15T15:30:33Z</cp:lastPrinted>
  <dcterms:created xsi:type="dcterms:W3CDTF">2019-01-27T20:52:28Z</dcterms:created>
  <dcterms:modified xsi:type="dcterms:W3CDTF">2020-10-27T17:31:38Z</dcterms:modified>
</cp:coreProperties>
</file>